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23760113" cy="151193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33" d="100"/>
          <a:sy n="33" d="100"/>
        </p:scale>
        <p:origin x="1397" y="4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970014" y="2474395"/>
            <a:ext cx="17820085" cy="5263774"/>
          </a:xfrm>
        </p:spPr>
        <p:txBody>
          <a:bodyPr anchor="b"/>
          <a:lstStyle>
            <a:lvl1pPr algn="ctr">
              <a:defRPr sz="11693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970014" y="7941160"/>
            <a:ext cx="17820085" cy="3650342"/>
          </a:xfrm>
        </p:spPr>
        <p:txBody>
          <a:bodyPr/>
          <a:lstStyle>
            <a:lvl1pPr marL="0" indent="0" algn="ctr">
              <a:buNone/>
              <a:defRPr sz="4677"/>
            </a:lvl1pPr>
            <a:lvl2pPr marL="890991" indent="0" algn="ctr">
              <a:buNone/>
              <a:defRPr sz="3898"/>
            </a:lvl2pPr>
            <a:lvl3pPr marL="1781983" indent="0" algn="ctr">
              <a:buNone/>
              <a:defRPr sz="3508"/>
            </a:lvl3pPr>
            <a:lvl4pPr marL="2672974" indent="0" algn="ctr">
              <a:buNone/>
              <a:defRPr sz="3118"/>
            </a:lvl4pPr>
            <a:lvl5pPr marL="3563965" indent="0" algn="ctr">
              <a:buNone/>
              <a:defRPr sz="3118"/>
            </a:lvl5pPr>
            <a:lvl6pPr marL="4454957" indent="0" algn="ctr">
              <a:buNone/>
              <a:defRPr sz="3118"/>
            </a:lvl6pPr>
            <a:lvl7pPr marL="5345948" indent="0" algn="ctr">
              <a:buNone/>
              <a:defRPr sz="3118"/>
            </a:lvl7pPr>
            <a:lvl8pPr marL="6236940" indent="0" algn="ctr">
              <a:buNone/>
              <a:defRPr sz="3118"/>
            </a:lvl8pPr>
            <a:lvl9pPr marL="7127931" indent="0" algn="ctr">
              <a:buNone/>
              <a:defRPr sz="3118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9341C-F4DB-43C2-884A-DEA64A7FBBE9}" type="datetimeFigureOut">
              <a:rPr lang="zh-CN" altLang="en-US" smtClean="0"/>
              <a:t>2024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966BA-1A5B-41C5-B4E7-7E6373DF05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1879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9341C-F4DB-43C2-884A-DEA64A7FBBE9}" type="datetimeFigureOut">
              <a:rPr lang="zh-CN" altLang="en-US" smtClean="0"/>
              <a:t>2024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966BA-1A5B-41C5-B4E7-7E6373DF05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3750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7003331" y="804966"/>
            <a:ext cx="5123274" cy="1281295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633508" y="804966"/>
            <a:ext cx="15072822" cy="1281295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9341C-F4DB-43C2-884A-DEA64A7FBBE9}" type="datetimeFigureOut">
              <a:rPr lang="zh-CN" altLang="en-US" smtClean="0"/>
              <a:t>2024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966BA-1A5B-41C5-B4E7-7E6373DF05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960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9341C-F4DB-43C2-884A-DEA64A7FBBE9}" type="datetimeFigureOut">
              <a:rPr lang="zh-CN" altLang="en-US" smtClean="0"/>
              <a:t>2024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966BA-1A5B-41C5-B4E7-7E6373DF05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8868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21133" y="3769340"/>
            <a:ext cx="20493097" cy="6289229"/>
          </a:xfrm>
        </p:spPr>
        <p:txBody>
          <a:bodyPr anchor="b"/>
          <a:lstStyle>
            <a:lvl1pPr>
              <a:defRPr sz="11693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21133" y="10118067"/>
            <a:ext cx="20493097" cy="3307357"/>
          </a:xfrm>
        </p:spPr>
        <p:txBody>
          <a:bodyPr/>
          <a:lstStyle>
            <a:lvl1pPr marL="0" indent="0">
              <a:buNone/>
              <a:defRPr sz="4677">
                <a:solidFill>
                  <a:schemeClr val="tx1">
                    <a:tint val="82000"/>
                  </a:schemeClr>
                </a:solidFill>
              </a:defRPr>
            </a:lvl1pPr>
            <a:lvl2pPr marL="890991" indent="0">
              <a:buNone/>
              <a:defRPr sz="3898">
                <a:solidFill>
                  <a:schemeClr val="tx1">
                    <a:tint val="82000"/>
                  </a:schemeClr>
                </a:solidFill>
              </a:defRPr>
            </a:lvl2pPr>
            <a:lvl3pPr marL="1781983" indent="0">
              <a:buNone/>
              <a:defRPr sz="3508">
                <a:solidFill>
                  <a:schemeClr val="tx1">
                    <a:tint val="82000"/>
                  </a:schemeClr>
                </a:solidFill>
              </a:defRPr>
            </a:lvl3pPr>
            <a:lvl4pPr marL="2672974" indent="0">
              <a:buNone/>
              <a:defRPr sz="3118">
                <a:solidFill>
                  <a:schemeClr val="tx1">
                    <a:tint val="82000"/>
                  </a:schemeClr>
                </a:solidFill>
              </a:defRPr>
            </a:lvl4pPr>
            <a:lvl5pPr marL="3563965" indent="0">
              <a:buNone/>
              <a:defRPr sz="3118">
                <a:solidFill>
                  <a:schemeClr val="tx1">
                    <a:tint val="82000"/>
                  </a:schemeClr>
                </a:solidFill>
              </a:defRPr>
            </a:lvl5pPr>
            <a:lvl6pPr marL="4454957" indent="0">
              <a:buNone/>
              <a:defRPr sz="3118">
                <a:solidFill>
                  <a:schemeClr val="tx1">
                    <a:tint val="82000"/>
                  </a:schemeClr>
                </a:solidFill>
              </a:defRPr>
            </a:lvl6pPr>
            <a:lvl7pPr marL="5345948" indent="0">
              <a:buNone/>
              <a:defRPr sz="3118">
                <a:solidFill>
                  <a:schemeClr val="tx1">
                    <a:tint val="82000"/>
                  </a:schemeClr>
                </a:solidFill>
              </a:defRPr>
            </a:lvl7pPr>
            <a:lvl8pPr marL="6236940" indent="0">
              <a:buNone/>
              <a:defRPr sz="3118">
                <a:solidFill>
                  <a:schemeClr val="tx1">
                    <a:tint val="82000"/>
                  </a:schemeClr>
                </a:solidFill>
              </a:defRPr>
            </a:lvl8pPr>
            <a:lvl9pPr marL="7127931" indent="0">
              <a:buNone/>
              <a:defRPr sz="3118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9341C-F4DB-43C2-884A-DEA64A7FBBE9}" type="datetimeFigureOut">
              <a:rPr lang="zh-CN" altLang="en-US" smtClean="0"/>
              <a:t>2024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966BA-1A5B-41C5-B4E7-7E6373DF05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79587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633508" y="4024827"/>
            <a:ext cx="10098048" cy="959308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028557" y="4024827"/>
            <a:ext cx="10098048" cy="959308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9341C-F4DB-43C2-884A-DEA64A7FBBE9}" type="datetimeFigureOut">
              <a:rPr lang="zh-CN" altLang="en-US" smtClean="0"/>
              <a:t>2024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966BA-1A5B-41C5-B4E7-7E6373DF05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4098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6603" y="804967"/>
            <a:ext cx="20493097" cy="29223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36603" y="3706342"/>
            <a:ext cx="10051641" cy="1816421"/>
          </a:xfrm>
        </p:spPr>
        <p:txBody>
          <a:bodyPr anchor="b"/>
          <a:lstStyle>
            <a:lvl1pPr marL="0" indent="0">
              <a:buNone/>
              <a:defRPr sz="4677" b="1"/>
            </a:lvl1pPr>
            <a:lvl2pPr marL="890991" indent="0">
              <a:buNone/>
              <a:defRPr sz="3898" b="1"/>
            </a:lvl2pPr>
            <a:lvl3pPr marL="1781983" indent="0">
              <a:buNone/>
              <a:defRPr sz="3508" b="1"/>
            </a:lvl3pPr>
            <a:lvl4pPr marL="2672974" indent="0">
              <a:buNone/>
              <a:defRPr sz="3118" b="1"/>
            </a:lvl4pPr>
            <a:lvl5pPr marL="3563965" indent="0">
              <a:buNone/>
              <a:defRPr sz="3118" b="1"/>
            </a:lvl5pPr>
            <a:lvl6pPr marL="4454957" indent="0">
              <a:buNone/>
              <a:defRPr sz="3118" b="1"/>
            </a:lvl6pPr>
            <a:lvl7pPr marL="5345948" indent="0">
              <a:buNone/>
              <a:defRPr sz="3118" b="1"/>
            </a:lvl7pPr>
            <a:lvl8pPr marL="6236940" indent="0">
              <a:buNone/>
              <a:defRPr sz="3118" b="1"/>
            </a:lvl8pPr>
            <a:lvl9pPr marL="7127931" indent="0">
              <a:buNone/>
              <a:defRPr sz="311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36603" y="5522763"/>
            <a:ext cx="10051641" cy="812315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028557" y="3706342"/>
            <a:ext cx="10101143" cy="1816421"/>
          </a:xfrm>
        </p:spPr>
        <p:txBody>
          <a:bodyPr anchor="b"/>
          <a:lstStyle>
            <a:lvl1pPr marL="0" indent="0">
              <a:buNone/>
              <a:defRPr sz="4677" b="1"/>
            </a:lvl1pPr>
            <a:lvl2pPr marL="890991" indent="0">
              <a:buNone/>
              <a:defRPr sz="3898" b="1"/>
            </a:lvl2pPr>
            <a:lvl3pPr marL="1781983" indent="0">
              <a:buNone/>
              <a:defRPr sz="3508" b="1"/>
            </a:lvl3pPr>
            <a:lvl4pPr marL="2672974" indent="0">
              <a:buNone/>
              <a:defRPr sz="3118" b="1"/>
            </a:lvl4pPr>
            <a:lvl5pPr marL="3563965" indent="0">
              <a:buNone/>
              <a:defRPr sz="3118" b="1"/>
            </a:lvl5pPr>
            <a:lvl6pPr marL="4454957" indent="0">
              <a:buNone/>
              <a:defRPr sz="3118" b="1"/>
            </a:lvl6pPr>
            <a:lvl7pPr marL="5345948" indent="0">
              <a:buNone/>
              <a:defRPr sz="3118" b="1"/>
            </a:lvl7pPr>
            <a:lvl8pPr marL="6236940" indent="0">
              <a:buNone/>
              <a:defRPr sz="3118" b="1"/>
            </a:lvl8pPr>
            <a:lvl9pPr marL="7127931" indent="0">
              <a:buNone/>
              <a:defRPr sz="311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028557" y="5522763"/>
            <a:ext cx="10101143" cy="812315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9341C-F4DB-43C2-884A-DEA64A7FBBE9}" type="datetimeFigureOut">
              <a:rPr lang="zh-CN" altLang="en-US" smtClean="0"/>
              <a:t>2024/12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966BA-1A5B-41C5-B4E7-7E6373DF05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987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9341C-F4DB-43C2-884A-DEA64A7FBBE9}" type="datetimeFigureOut">
              <a:rPr lang="zh-CN" altLang="en-US" smtClean="0"/>
              <a:t>2024/12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966BA-1A5B-41C5-B4E7-7E6373DF05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02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9341C-F4DB-43C2-884A-DEA64A7FBBE9}" type="datetimeFigureOut">
              <a:rPr lang="zh-CN" altLang="en-US" smtClean="0"/>
              <a:t>2024/12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966BA-1A5B-41C5-B4E7-7E6373DF05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141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6604" y="1007957"/>
            <a:ext cx="7663254" cy="3527848"/>
          </a:xfrm>
        </p:spPr>
        <p:txBody>
          <a:bodyPr anchor="b"/>
          <a:lstStyle>
            <a:lvl1pPr>
              <a:defRPr sz="623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101143" y="2176908"/>
            <a:ext cx="12028557" cy="10744538"/>
          </a:xfrm>
        </p:spPr>
        <p:txBody>
          <a:bodyPr/>
          <a:lstStyle>
            <a:lvl1pPr>
              <a:defRPr sz="6236"/>
            </a:lvl1pPr>
            <a:lvl2pPr>
              <a:defRPr sz="5457"/>
            </a:lvl2pPr>
            <a:lvl3pPr>
              <a:defRPr sz="4677"/>
            </a:lvl3pPr>
            <a:lvl4pPr>
              <a:defRPr sz="3898"/>
            </a:lvl4pPr>
            <a:lvl5pPr>
              <a:defRPr sz="3898"/>
            </a:lvl5pPr>
            <a:lvl6pPr>
              <a:defRPr sz="3898"/>
            </a:lvl6pPr>
            <a:lvl7pPr>
              <a:defRPr sz="3898"/>
            </a:lvl7pPr>
            <a:lvl8pPr>
              <a:defRPr sz="3898"/>
            </a:lvl8pPr>
            <a:lvl9pPr>
              <a:defRPr sz="389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36604" y="4535805"/>
            <a:ext cx="7663254" cy="8403140"/>
          </a:xfrm>
        </p:spPr>
        <p:txBody>
          <a:bodyPr/>
          <a:lstStyle>
            <a:lvl1pPr marL="0" indent="0">
              <a:buNone/>
              <a:defRPr sz="3118"/>
            </a:lvl1pPr>
            <a:lvl2pPr marL="890991" indent="0">
              <a:buNone/>
              <a:defRPr sz="2728"/>
            </a:lvl2pPr>
            <a:lvl3pPr marL="1781983" indent="0">
              <a:buNone/>
              <a:defRPr sz="2339"/>
            </a:lvl3pPr>
            <a:lvl4pPr marL="2672974" indent="0">
              <a:buNone/>
              <a:defRPr sz="1949"/>
            </a:lvl4pPr>
            <a:lvl5pPr marL="3563965" indent="0">
              <a:buNone/>
              <a:defRPr sz="1949"/>
            </a:lvl5pPr>
            <a:lvl6pPr marL="4454957" indent="0">
              <a:buNone/>
              <a:defRPr sz="1949"/>
            </a:lvl6pPr>
            <a:lvl7pPr marL="5345948" indent="0">
              <a:buNone/>
              <a:defRPr sz="1949"/>
            </a:lvl7pPr>
            <a:lvl8pPr marL="6236940" indent="0">
              <a:buNone/>
              <a:defRPr sz="1949"/>
            </a:lvl8pPr>
            <a:lvl9pPr marL="7127931" indent="0">
              <a:buNone/>
              <a:defRPr sz="194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9341C-F4DB-43C2-884A-DEA64A7FBBE9}" type="datetimeFigureOut">
              <a:rPr lang="zh-CN" altLang="en-US" smtClean="0"/>
              <a:t>2024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966BA-1A5B-41C5-B4E7-7E6373DF05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5601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6604" y="1007957"/>
            <a:ext cx="7663254" cy="3527848"/>
          </a:xfrm>
        </p:spPr>
        <p:txBody>
          <a:bodyPr anchor="b"/>
          <a:lstStyle>
            <a:lvl1pPr>
              <a:defRPr sz="623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101143" y="2176908"/>
            <a:ext cx="12028557" cy="10744538"/>
          </a:xfrm>
        </p:spPr>
        <p:txBody>
          <a:bodyPr anchor="t"/>
          <a:lstStyle>
            <a:lvl1pPr marL="0" indent="0">
              <a:buNone/>
              <a:defRPr sz="6236"/>
            </a:lvl1pPr>
            <a:lvl2pPr marL="890991" indent="0">
              <a:buNone/>
              <a:defRPr sz="5457"/>
            </a:lvl2pPr>
            <a:lvl3pPr marL="1781983" indent="0">
              <a:buNone/>
              <a:defRPr sz="4677"/>
            </a:lvl3pPr>
            <a:lvl4pPr marL="2672974" indent="0">
              <a:buNone/>
              <a:defRPr sz="3898"/>
            </a:lvl4pPr>
            <a:lvl5pPr marL="3563965" indent="0">
              <a:buNone/>
              <a:defRPr sz="3898"/>
            </a:lvl5pPr>
            <a:lvl6pPr marL="4454957" indent="0">
              <a:buNone/>
              <a:defRPr sz="3898"/>
            </a:lvl6pPr>
            <a:lvl7pPr marL="5345948" indent="0">
              <a:buNone/>
              <a:defRPr sz="3898"/>
            </a:lvl7pPr>
            <a:lvl8pPr marL="6236940" indent="0">
              <a:buNone/>
              <a:defRPr sz="3898"/>
            </a:lvl8pPr>
            <a:lvl9pPr marL="7127931" indent="0">
              <a:buNone/>
              <a:defRPr sz="3898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36604" y="4535805"/>
            <a:ext cx="7663254" cy="8403140"/>
          </a:xfrm>
        </p:spPr>
        <p:txBody>
          <a:bodyPr/>
          <a:lstStyle>
            <a:lvl1pPr marL="0" indent="0">
              <a:buNone/>
              <a:defRPr sz="3118"/>
            </a:lvl1pPr>
            <a:lvl2pPr marL="890991" indent="0">
              <a:buNone/>
              <a:defRPr sz="2728"/>
            </a:lvl2pPr>
            <a:lvl3pPr marL="1781983" indent="0">
              <a:buNone/>
              <a:defRPr sz="2339"/>
            </a:lvl3pPr>
            <a:lvl4pPr marL="2672974" indent="0">
              <a:buNone/>
              <a:defRPr sz="1949"/>
            </a:lvl4pPr>
            <a:lvl5pPr marL="3563965" indent="0">
              <a:buNone/>
              <a:defRPr sz="1949"/>
            </a:lvl5pPr>
            <a:lvl6pPr marL="4454957" indent="0">
              <a:buNone/>
              <a:defRPr sz="1949"/>
            </a:lvl6pPr>
            <a:lvl7pPr marL="5345948" indent="0">
              <a:buNone/>
              <a:defRPr sz="1949"/>
            </a:lvl7pPr>
            <a:lvl8pPr marL="6236940" indent="0">
              <a:buNone/>
              <a:defRPr sz="1949"/>
            </a:lvl8pPr>
            <a:lvl9pPr marL="7127931" indent="0">
              <a:buNone/>
              <a:defRPr sz="194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9341C-F4DB-43C2-884A-DEA64A7FBBE9}" type="datetimeFigureOut">
              <a:rPr lang="zh-CN" altLang="en-US" smtClean="0"/>
              <a:t>2024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966BA-1A5B-41C5-B4E7-7E6373DF05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0508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633508" y="804967"/>
            <a:ext cx="20493097" cy="29223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33508" y="4024827"/>
            <a:ext cx="20493097" cy="959308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633508" y="14013399"/>
            <a:ext cx="5346025" cy="8049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3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D9341C-F4DB-43C2-884A-DEA64A7FBBE9}" type="datetimeFigureOut">
              <a:rPr lang="zh-CN" altLang="en-US" smtClean="0"/>
              <a:t>2024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870538" y="14013399"/>
            <a:ext cx="8019038" cy="8049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3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80580" y="14013399"/>
            <a:ext cx="5346025" cy="8049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3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AD966BA-1A5B-41C5-B4E7-7E6373DF05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5942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781983" rtl="0" eaLnBrk="1" latinLnBrk="0" hangingPunct="1">
        <a:lnSpc>
          <a:spcPct val="90000"/>
        </a:lnSpc>
        <a:spcBef>
          <a:spcPct val="0"/>
        </a:spcBef>
        <a:buNone/>
        <a:defRPr sz="85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45496" indent="-445496" algn="l" defTabSz="1781983" rtl="0" eaLnBrk="1" latinLnBrk="0" hangingPunct="1">
        <a:lnSpc>
          <a:spcPct val="90000"/>
        </a:lnSpc>
        <a:spcBef>
          <a:spcPts val="1949"/>
        </a:spcBef>
        <a:buFont typeface="Arial" panose="020B0604020202020204" pitchFamily="34" charset="0"/>
        <a:buChar char="•"/>
        <a:defRPr sz="5457" kern="1200">
          <a:solidFill>
            <a:schemeClr val="tx1"/>
          </a:solidFill>
          <a:latin typeface="+mn-lt"/>
          <a:ea typeface="+mn-ea"/>
          <a:cs typeface="+mn-cs"/>
        </a:defRPr>
      </a:lvl1pPr>
      <a:lvl2pPr marL="1336487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sz="4677" kern="1200">
          <a:solidFill>
            <a:schemeClr val="tx1"/>
          </a:solidFill>
          <a:latin typeface="+mn-lt"/>
          <a:ea typeface="+mn-ea"/>
          <a:cs typeface="+mn-cs"/>
        </a:defRPr>
      </a:lvl2pPr>
      <a:lvl3pPr marL="2227478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3pPr>
      <a:lvl4pPr marL="3118470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sz="3508" kern="1200">
          <a:solidFill>
            <a:schemeClr val="tx1"/>
          </a:solidFill>
          <a:latin typeface="+mn-lt"/>
          <a:ea typeface="+mn-ea"/>
          <a:cs typeface="+mn-cs"/>
        </a:defRPr>
      </a:lvl4pPr>
      <a:lvl5pPr marL="4009461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sz="3508" kern="1200">
          <a:solidFill>
            <a:schemeClr val="tx1"/>
          </a:solidFill>
          <a:latin typeface="+mn-lt"/>
          <a:ea typeface="+mn-ea"/>
          <a:cs typeface="+mn-cs"/>
        </a:defRPr>
      </a:lvl5pPr>
      <a:lvl6pPr marL="4900452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sz="3508" kern="1200">
          <a:solidFill>
            <a:schemeClr val="tx1"/>
          </a:solidFill>
          <a:latin typeface="+mn-lt"/>
          <a:ea typeface="+mn-ea"/>
          <a:cs typeface="+mn-cs"/>
        </a:defRPr>
      </a:lvl6pPr>
      <a:lvl7pPr marL="5791444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sz="3508" kern="1200">
          <a:solidFill>
            <a:schemeClr val="tx1"/>
          </a:solidFill>
          <a:latin typeface="+mn-lt"/>
          <a:ea typeface="+mn-ea"/>
          <a:cs typeface="+mn-cs"/>
        </a:defRPr>
      </a:lvl7pPr>
      <a:lvl8pPr marL="6682435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sz="3508" kern="1200">
          <a:solidFill>
            <a:schemeClr val="tx1"/>
          </a:solidFill>
          <a:latin typeface="+mn-lt"/>
          <a:ea typeface="+mn-ea"/>
          <a:cs typeface="+mn-cs"/>
        </a:defRPr>
      </a:lvl8pPr>
      <a:lvl9pPr marL="7573427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sz="350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1pPr>
      <a:lvl2pPr marL="890991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2pPr>
      <a:lvl3pPr marL="1781983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3pPr>
      <a:lvl4pPr marL="2672974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4pPr>
      <a:lvl5pPr marL="3563965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5pPr>
      <a:lvl6pPr marL="4454957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6pPr>
      <a:lvl7pPr marL="5345948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7pPr>
      <a:lvl8pPr marL="6236940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8pPr>
      <a:lvl9pPr marL="7127931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6" name="组合 155">
            <a:extLst>
              <a:ext uri="{FF2B5EF4-FFF2-40B4-BE49-F238E27FC236}">
                <a16:creationId xmlns:a16="http://schemas.microsoft.com/office/drawing/2014/main" id="{18259671-65D2-E081-8D4C-752B178CAD08}"/>
              </a:ext>
            </a:extLst>
          </p:cNvPr>
          <p:cNvGrpSpPr/>
          <p:nvPr/>
        </p:nvGrpSpPr>
        <p:grpSpPr>
          <a:xfrm>
            <a:off x="261198" y="1325586"/>
            <a:ext cx="23237716" cy="12989118"/>
            <a:chOff x="-6571450" y="-3748143"/>
            <a:chExt cx="23237716" cy="12989118"/>
          </a:xfrm>
        </p:grpSpPr>
        <p:sp>
          <p:nvSpPr>
            <p:cNvPr id="157" name="文本框 156">
              <a:extLst>
                <a:ext uri="{FF2B5EF4-FFF2-40B4-BE49-F238E27FC236}">
                  <a16:creationId xmlns:a16="http://schemas.microsoft.com/office/drawing/2014/main" id="{D0C41201-8CB1-F3B1-6C19-14151829DBA5}"/>
                </a:ext>
              </a:extLst>
            </p:cNvPr>
            <p:cNvSpPr txBox="1"/>
            <p:nvPr/>
          </p:nvSpPr>
          <p:spPr>
            <a:xfrm>
              <a:off x="-4229405" y="-3202629"/>
              <a:ext cx="3695688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Ground truth of RNA profil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文本框 157">
              <a:extLst>
                <a:ext uri="{FF2B5EF4-FFF2-40B4-BE49-F238E27FC236}">
                  <a16:creationId xmlns:a16="http://schemas.microsoft.com/office/drawing/2014/main" id="{9EFEE29D-82D9-FCEB-0A4D-B1988FCA3A84}"/>
                </a:ext>
              </a:extLst>
            </p:cNvPr>
            <p:cNvSpPr txBox="1"/>
            <p:nvPr/>
          </p:nvSpPr>
          <p:spPr>
            <a:xfrm>
              <a:off x="-2918397" y="4660051"/>
              <a:ext cx="619462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ation and ground truth of RNA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文本框 158">
              <a:extLst>
                <a:ext uri="{FF2B5EF4-FFF2-40B4-BE49-F238E27FC236}">
                  <a16:creationId xmlns:a16="http://schemas.microsoft.com/office/drawing/2014/main" id="{1A85D515-2884-2D69-7BF6-32D81420C853}"/>
                </a:ext>
              </a:extLst>
            </p:cNvPr>
            <p:cNvSpPr txBox="1"/>
            <p:nvPr/>
          </p:nvSpPr>
          <p:spPr>
            <a:xfrm>
              <a:off x="7556994" y="4660051"/>
              <a:ext cx="5900777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ation and ground truth of ATAC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0" name="直接连接符 159">
              <a:extLst>
                <a:ext uri="{FF2B5EF4-FFF2-40B4-BE49-F238E27FC236}">
                  <a16:creationId xmlns:a16="http://schemas.microsoft.com/office/drawing/2014/main" id="{B8CD93DE-1779-F466-0A21-BE539E3C8CAB}"/>
                </a:ext>
              </a:extLst>
            </p:cNvPr>
            <p:cNvCxnSpPr>
              <a:cxnSpLocks/>
            </p:cNvCxnSpPr>
            <p:nvPr/>
          </p:nvCxnSpPr>
          <p:spPr>
            <a:xfrm>
              <a:off x="10410" y="-2893020"/>
              <a:ext cx="0" cy="6733500"/>
            </a:xfrm>
            <a:prstGeom prst="line">
              <a:avLst/>
            </a:prstGeom>
            <a:noFill/>
            <a:ln w="762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pic>
          <p:nvPicPr>
            <p:cNvPr id="161" name="图片 160" descr="散点图&#10;&#10;低可信度描述已自动生成">
              <a:extLst>
                <a:ext uri="{FF2B5EF4-FFF2-40B4-BE49-F238E27FC236}">
                  <a16:creationId xmlns:a16="http://schemas.microsoft.com/office/drawing/2014/main" id="{C28BEDC5-5EAA-D76A-E9D2-AF03E87FFA7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234720" y="-2824813"/>
              <a:ext cx="3743845" cy="2824813"/>
            </a:xfrm>
            <a:prstGeom prst="rect">
              <a:avLst/>
            </a:prstGeom>
          </p:spPr>
        </p:pic>
        <p:pic>
          <p:nvPicPr>
            <p:cNvPr id="162" name="图片 161" descr="散点图&#10;&#10;描述已自动生成">
              <a:extLst>
                <a:ext uri="{FF2B5EF4-FFF2-40B4-BE49-F238E27FC236}">
                  <a16:creationId xmlns:a16="http://schemas.microsoft.com/office/drawing/2014/main" id="{82E595A7-5770-D06B-0EC4-CAE9622C2AE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234720" y="871719"/>
              <a:ext cx="3748556" cy="2828368"/>
            </a:xfrm>
            <a:prstGeom prst="rect">
              <a:avLst/>
            </a:prstGeom>
          </p:spPr>
        </p:pic>
        <p:pic>
          <p:nvPicPr>
            <p:cNvPr id="163" name="图片 162" descr="地图, 散点图&#10;&#10;描述已自动生成">
              <a:extLst>
                <a:ext uri="{FF2B5EF4-FFF2-40B4-BE49-F238E27FC236}">
                  <a16:creationId xmlns:a16="http://schemas.microsoft.com/office/drawing/2014/main" id="{E15F2E07-532A-A020-D437-55BC393606C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0839" y="-2824813"/>
              <a:ext cx="3743844" cy="2824813"/>
            </a:xfrm>
            <a:prstGeom prst="rect">
              <a:avLst/>
            </a:prstGeom>
          </p:spPr>
        </p:pic>
        <p:pic>
          <p:nvPicPr>
            <p:cNvPr id="164" name="图片 163" descr="图片包含 背景图案&#10;&#10;描述已自动生成">
              <a:extLst>
                <a:ext uri="{FF2B5EF4-FFF2-40B4-BE49-F238E27FC236}">
                  <a16:creationId xmlns:a16="http://schemas.microsoft.com/office/drawing/2014/main" id="{B57F996A-0D82-0473-367D-2B07AE14987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6985" y="871719"/>
              <a:ext cx="3743842" cy="2824811"/>
            </a:xfrm>
            <a:prstGeom prst="rect">
              <a:avLst/>
            </a:prstGeom>
          </p:spPr>
        </p:pic>
        <p:pic>
          <p:nvPicPr>
            <p:cNvPr id="165" name="图片 164" descr="散点图&#10;&#10;描述已自动生成">
              <a:extLst>
                <a:ext uri="{FF2B5EF4-FFF2-40B4-BE49-F238E27FC236}">
                  <a16:creationId xmlns:a16="http://schemas.microsoft.com/office/drawing/2014/main" id="{6E56E588-C97D-9BEE-8178-73A31F1B4EE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04386" y="-2824811"/>
              <a:ext cx="3743842" cy="2824811"/>
            </a:xfrm>
            <a:prstGeom prst="rect">
              <a:avLst/>
            </a:prstGeom>
          </p:spPr>
        </p:pic>
        <p:pic>
          <p:nvPicPr>
            <p:cNvPr id="166" name="图片 165" descr="图片包含 背景图案&#10;&#10;描述已自动生成">
              <a:extLst>
                <a:ext uri="{FF2B5EF4-FFF2-40B4-BE49-F238E27FC236}">
                  <a16:creationId xmlns:a16="http://schemas.microsoft.com/office/drawing/2014/main" id="{F5B47E57-3F12-992C-0E04-9BA766231CA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04386" y="871719"/>
              <a:ext cx="3743842" cy="2824811"/>
            </a:xfrm>
            <a:prstGeom prst="rect">
              <a:avLst/>
            </a:prstGeom>
          </p:spPr>
        </p:pic>
        <p:pic>
          <p:nvPicPr>
            <p:cNvPr id="167" name="图片 166" descr="背景图案&#10;&#10;描述已自动生成">
              <a:extLst>
                <a:ext uri="{FF2B5EF4-FFF2-40B4-BE49-F238E27FC236}">
                  <a16:creationId xmlns:a16="http://schemas.microsoft.com/office/drawing/2014/main" id="{67A1055D-1817-54DB-A184-7EDBB7C06CF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282385" y="-2824810"/>
              <a:ext cx="3743840" cy="2824810"/>
            </a:xfrm>
            <a:prstGeom prst="rect">
              <a:avLst/>
            </a:prstGeom>
          </p:spPr>
        </p:pic>
        <p:pic>
          <p:nvPicPr>
            <p:cNvPr id="168" name="图片 167" descr="背景图案&#10;&#10;描述已自动生成">
              <a:extLst>
                <a:ext uri="{FF2B5EF4-FFF2-40B4-BE49-F238E27FC236}">
                  <a16:creationId xmlns:a16="http://schemas.microsoft.com/office/drawing/2014/main" id="{FEA3B593-7F31-7336-89D1-04ECB5D7FBE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290129" y="871719"/>
              <a:ext cx="3743841" cy="2824810"/>
            </a:xfrm>
            <a:prstGeom prst="rect">
              <a:avLst/>
            </a:prstGeom>
          </p:spPr>
        </p:pic>
        <p:pic>
          <p:nvPicPr>
            <p:cNvPr id="169" name="图片 168" descr="背景图案&#10;&#10;描述已自动生成">
              <a:extLst>
                <a:ext uri="{FF2B5EF4-FFF2-40B4-BE49-F238E27FC236}">
                  <a16:creationId xmlns:a16="http://schemas.microsoft.com/office/drawing/2014/main" id="{3220580A-FFAA-4115-D578-4FFAEE655A2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221526" y="5508017"/>
              <a:ext cx="3748556" cy="2828368"/>
            </a:xfrm>
            <a:prstGeom prst="rect">
              <a:avLst/>
            </a:prstGeom>
          </p:spPr>
        </p:pic>
        <p:pic>
          <p:nvPicPr>
            <p:cNvPr id="170" name="图片 169" descr="图片包含 游戏机&#10;&#10;描述已自动生成">
              <a:extLst>
                <a:ext uri="{FF2B5EF4-FFF2-40B4-BE49-F238E27FC236}">
                  <a16:creationId xmlns:a16="http://schemas.microsoft.com/office/drawing/2014/main" id="{2D3BDD31-BF42-CB62-7E9C-095366AE7238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7919" y="5508017"/>
              <a:ext cx="3743842" cy="2824811"/>
            </a:xfrm>
            <a:prstGeom prst="rect">
              <a:avLst/>
            </a:prstGeom>
          </p:spPr>
        </p:pic>
        <p:pic>
          <p:nvPicPr>
            <p:cNvPr id="171" name="图片 170" descr="图片包含 地图&#10;&#10;描述已自动生成">
              <a:extLst>
                <a:ext uri="{FF2B5EF4-FFF2-40B4-BE49-F238E27FC236}">
                  <a16:creationId xmlns:a16="http://schemas.microsoft.com/office/drawing/2014/main" id="{2A2AC25C-81B6-4291-57ED-E8BA3D5FBE0A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12650" y="5508017"/>
              <a:ext cx="3743842" cy="2824811"/>
            </a:xfrm>
            <a:prstGeom prst="rect">
              <a:avLst/>
            </a:prstGeom>
          </p:spPr>
        </p:pic>
        <p:pic>
          <p:nvPicPr>
            <p:cNvPr id="172" name="图片 171" descr="形状, 地图, 箭头&#10;&#10;描述已自动生成">
              <a:extLst>
                <a:ext uri="{FF2B5EF4-FFF2-40B4-BE49-F238E27FC236}">
                  <a16:creationId xmlns:a16="http://schemas.microsoft.com/office/drawing/2014/main" id="{8049CFA3-25EE-DB89-5825-06F56224A14C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591628" y="5466986"/>
              <a:ext cx="3743841" cy="2824810"/>
            </a:xfrm>
            <a:prstGeom prst="rect">
              <a:avLst/>
            </a:prstGeom>
          </p:spPr>
        </p:pic>
        <p:pic>
          <p:nvPicPr>
            <p:cNvPr id="173" name="图片 172" descr="散点图&#10;&#10;描述已自动生成">
              <a:extLst>
                <a:ext uri="{FF2B5EF4-FFF2-40B4-BE49-F238E27FC236}">
                  <a16:creationId xmlns:a16="http://schemas.microsoft.com/office/drawing/2014/main" id="{5199FAFE-A103-0A95-DCE9-1B489B66EF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472" t="33305" b="34080"/>
            <a:stretch/>
          </p:blipFill>
          <p:spPr>
            <a:xfrm>
              <a:off x="14085475" y="-786714"/>
              <a:ext cx="2580791" cy="2292080"/>
            </a:xfrm>
            <a:prstGeom prst="rect">
              <a:avLst/>
            </a:prstGeom>
          </p:spPr>
        </p:pic>
        <p:sp>
          <p:nvSpPr>
            <p:cNvPr id="174" name="椭圆 173">
              <a:extLst>
                <a:ext uri="{FF2B5EF4-FFF2-40B4-BE49-F238E27FC236}">
                  <a16:creationId xmlns:a16="http://schemas.microsoft.com/office/drawing/2014/main" id="{5DC032B2-2A72-14DD-D288-E8B3273DEAE3}"/>
                </a:ext>
              </a:extLst>
            </p:cNvPr>
            <p:cNvSpPr/>
            <p:nvPr/>
          </p:nvSpPr>
          <p:spPr>
            <a:xfrm>
              <a:off x="2197818" y="8880975"/>
              <a:ext cx="360000" cy="360000"/>
            </a:xfrm>
            <a:prstGeom prst="ellipse">
              <a:avLst/>
            </a:prstGeom>
            <a:solidFill>
              <a:srgbClr val="FE7F0E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75" name="椭圆 174">
              <a:extLst>
                <a:ext uri="{FF2B5EF4-FFF2-40B4-BE49-F238E27FC236}">
                  <a16:creationId xmlns:a16="http://schemas.microsoft.com/office/drawing/2014/main" id="{F97F8AF6-158E-DB1A-D78D-B437F980720F}"/>
                </a:ext>
              </a:extLst>
            </p:cNvPr>
            <p:cNvSpPr/>
            <p:nvPr/>
          </p:nvSpPr>
          <p:spPr>
            <a:xfrm>
              <a:off x="2197818" y="8420426"/>
              <a:ext cx="360000" cy="360000"/>
            </a:xfrm>
            <a:prstGeom prst="ellipse">
              <a:avLst/>
            </a:prstGeom>
            <a:solidFill>
              <a:srgbClr val="2177B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76" name="文本框 175">
              <a:extLst>
                <a:ext uri="{FF2B5EF4-FFF2-40B4-BE49-F238E27FC236}">
                  <a16:creationId xmlns:a16="http://schemas.microsoft.com/office/drawing/2014/main" id="{C618159C-F5E2-E6BF-0B69-2CB5DA784F3D}"/>
                </a:ext>
              </a:extLst>
            </p:cNvPr>
            <p:cNvSpPr txBox="1"/>
            <p:nvPr/>
          </p:nvSpPr>
          <p:spPr>
            <a:xfrm>
              <a:off x="2557818" y="8840865"/>
              <a:ext cx="180257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ruth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文本框 176">
              <a:extLst>
                <a:ext uri="{FF2B5EF4-FFF2-40B4-BE49-F238E27FC236}">
                  <a16:creationId xmlns:a16="http://schemas.microsoft.com/office/drawing/2014/main" id="{ED32B12C-AF76-14E9-B53C-BE1B8166ED38}"/>
                </a:ext>
              </a:extLst>
            </p:cNvPr>
            <p:cNvSpPr txBox="1"/>
            <p:nvPr/>
          </p:nvSpPr>
          <p:spPr>
            <a:xfrm>
              <a:off x="2571952" y="8400371"/>
              <a:ext cx="166733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ation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椭圆 177">
              <a:extLst>
                <a:ext uri="{FF2B5EF4-FFF2-40B4-BE49-F238E27FC236}">
                  <a16:creationId xmlns:a16="http://schemas.microsoft.com/office/drawing/2014/main" id="{F8814329-969A-5427-F111-634F1E9ADB48}"/>
                </a:ext>
              </a:extLst>
            </p:cNvPr>
            <p:cNvSpPr/>
            <p:nvPr/>
          </p:nvSpPr>
          <p:spPr>
            <a:xfrm>
              <a:off x="12083274" y="8859127"/>
              <a:ext cx="360000" cy="360000"/>
            </a:xfrm>
            <a:prstGeom prst="ellipse">
              <a:avLst/>
            </a:prstGeom>
            <a:solidFill>
              <a:srgbClr val="FE7F0E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79" name="椭圆 178">
              <a:extLst>
                <a:ext uri="{FF2B5EF4-FFF2-40B4-BE49-F238E27FC236}">
                  <a16:creationId xmlns:a16="http://schemas.microsoft.com/office/drawing/2014/main" id="{4FDB704D-6173-5DC0-197B-DEA7E57DF1A8}"/>
                </a:ext>
              </a:extLst>
            </p:cNvPr>
            <p:cNvSpPr/>
            <p:nvPr/>
          </p:nvSpPr>
          <p:spPr>
            <a:xfrm>
              <a:off x="12083274" y="8398578"/>
              <a:ext cx="360000" cy="360000"/>
            </a:xfrm>
            <a:prstGeom prst="ellipse">
              <a:avLst/>
            </a:prstGeom>
            <a:solidFill>
              <a:srgbClr val="2177B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0" name="文本框 179">
              <a:extLst>
                <a:ext uri="{FF2B5EF4-FFF2-40B4-BE49-F238E27FC236}">
                  <a16:creationId xmlns:a16="http://schemas.microsoft.com/office/drawing/2014/main" id="{0B523EF2-D0E0-C434-DBC9-E9B8FDBCC445}"/>
                </a:ext>
              </a:extLst>
            </p:cNvPr>
            <p:cNvSpPr txBox="1"/>
            <p:nvPr/>
          </p:nvSpPr>
          <p:spPr>
            <a:xfrm>
              <a:off x="12443274" y="8819017"/>
              <a:ext cx="180257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ruth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文本框 180">
              <a:extLst>
                <a:ext uri="{FF2B5EF4-FFF2-40B4-BE49-F238E27FC236}">
                  <a16:creationId xmlns:a16="http://schemas.microsoft.com/office/drawing/2014/main" id="{183A2660-EC49-E611-248C-17D4F96AB2AC}"/>
                </a:ext>
              </a:extLst>
            </p:cNvPr>
            <p:cNvSpPr txBox="1"/>
            <p:nvPr/>
          </p:nvSpPr>
          <p:spPr>
            <a:xfrm>
              <a:off x="12457408" y="8378523"/>
              <a:ext cx="166733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ation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文本框 181">
              <a:extLst>
                <a:ext uri="{FF2B5EF4-FFF2-40B4-BE49-F238E27FC236}">
                  <a16:creationId xmlns:a16="http://schemas.microsoft.com/office/drawing/2014/main" id="{46557CDD-0AC5-C3F7-D5F8-6C585B66C464}"/>
                </a:ext>
              </a:extLst>
            </p:cNvPr>
            <p:cNvSpPr txBox="1"/>
            <p:nvPr/>
          </p:nvSpPr>
          <p:spPr>
            <a:xfrm>
              <a:off x="-3425847" y="5156964"/>
              <a:ext cx="219456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ll type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文本框 182">
              <a:extLst>
                <a:ext uri="{FF2B5EF4-FFF2-40B4-BE49-F238E27FC236}">
                  <a16:creationId xmlns:a16="http://schemas.microsoft.com/office/drawing/2014/main" id="{575429E5-0725-DC11-2F86-25EA7B0E0666}"/>
                </a:ext>
              </a:extLst>
            </p:cNvPr>
            <p:cNvSpPr txBox="1"/>
            <p:nvPr/>
          </p:nvSpPr>
          <p:spPr>
            <a:xfrm>
              <a:off x="1683655" y="5156964"/>
              <a:ext cx="219456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ource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文本框 183">
              <a:extLst>
                <a:ext uri="{FF2B5EF4-FFF2-40B4-BE49-F238E27FC236}">
                  <a16:creationId xmlns:a16="http://schemas.microsoft.com/office/drawing/2014/main" id="{5E25622D-7977-8E43-A2A0-5BA30B1965AE}"/>
                </a:ext>
              </a:extLst>
            </p:cNvPr>
            <p:cNvSpPr txBox="1"/>
            <p:nvPr/>
          </p:nvSpPr>
          <p:spPr>
            <a:xfrm>
              <a:off x="6422029" y="5156964"/>
              <a:ext cx="219456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ll type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文本框 184">
              <a:extLst>
                <a:ext uri="{FF2B5EF4-FFF2-40B4-BE49-F238E27FC236}">
                  <a16:creationId xmlns:a16="http://schemas.microsoft.com/office/drawing/2014/main" id="{DEB33F5D-8B24-F686-8423-A37C89E33D85}"/>
                </a:ext>
              </a:extLst>
            </p:cNvPr>
            <p:cNvSpPr txBox="1"/>
            <p:nvPr/>
          </p:nvSpPr>
          <p:spPr>
            <a:xfrm>
              <a:off x="11531531" y="5156964"/>
              <a:ext cx="219456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ource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文本框 185">
              <a:extLst>
                <a:ext uri="{FF2B5EF4-FFF2-40B4-BE49-F238E27FC236}">
                  <a16:creationId xmlns:a16="http://schemas.microsoft.com/office/drawing/2014/main" id="{2A203B40-7980-3F0A-367F-E7422A0315B2}"/>
                </a:ext>
              </a:extLst>
            </p:cNvPr>
            <p:cNvSpPr txBox="1"/>
            <p:nvPr/>
          </p:nvSpPr>
          <p:spPr>
            <a:xfrm>
              <a:off x="-4249205" y="493903"/>
              <a:ext cx="3743844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Ground truth of ATAC profil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文本框 186">
              <a:extLst>
                <a:ext uri="{FF2B5EF4-FFF2-40B4-BE49-F238E27FC236}">
                  <a16:creationId xmlns:a16="http://schemas.microsoft.com/office/drawing/2014/main" id="{ADBBD493-0821-A96E-01DC-9D557A729020}"/>
                </a:ext>
              </a:extLst>
            </p:cNvPr>
            <p:cNvSpPr txBox="1"/>
            <p:nvPr/>
          </p:nvSpPr>
          <p:spPr>
            <a:xfrm>
              <a:off x="-6557593" y="-3748143"/>
              <a:ext cx="3470488" cy="92333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5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0" lang="zh-CN" altLang="en-US" sz="5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文本框 187">
              <a:extLst>
                <a:ext uri="{FF2B5EF4-FFF2-40B4-BE49-F238E27FC236}">
                  <a16:creationId xmlns:a16="http://schemas.microsoft.com/office/drawing/2014/main" id="{C279D7C7-EEF3-6BC8-8F72-AA25E3AF8F38}"/>
                </a:ext>
              </a:extLst>
            </p:cNvPr>
            <p:cNvSpPr txBox="1"/>
            <p:nvPr/>
          </p:nvSpPr>
          <p:spPr>
            <a:xfrm>
              <a:off x="-6571450" y="4083038"/>
              <a:ext cx="3470488" cy="92333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5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0" lang="zh-CN" altLang="en-US" sz="5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文本框 188">
              <a:extLst>
                <a:ext uri="{FF2B5EF4-FFF2-40B4-BE49-F238E27FC236}">
                  <a16:creationId xmlns:a16="http://schemas.microsoft.com/office/drawing/2014/main" id="{4CC6CC68-1103-840D-F51B-C1EE4AA7A6EF}"/>
                </a:ext>
              </a:extLst>
            </p:cNvPr>
            <p:cNvSpPr txBox="1"/>
            <p:nvPr/>
          </p:nvSpPr>
          <p:spPr>
            <a:xfrm>
              <a:off x="1443778" y="-3202629"/>
              <a:ext cx="219456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文本框 189">
              <a:extLst>
                <a:ext uri="{FF2B5EF4-FFF2-40B4-BE49-F238E27FC236}">
                  <a16:creationId xmlns:a16="http://schemas.microsoft.com/office/drawing/2014/main" id="{101F6F38-E1E8-5548-FA3A-3A23BB777545}"/>
                </a:ext>
              </a:extLst>
            </p:cNvPr>
            <p:cNvSpPr txBox="1"/>
            <p:nvPr/>
          </p:nvSpPr>
          <p:spPr>
            <a:xfrm>
              <a:off x="6079990" y="-3202629"/>
              <a:ext cx="2758824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VAEIT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文本框 190">
              <a:extLst>
                <a:ext uri="{FF2B5EF4-FFF2-40B4-BE49-F238E27FC236}">
                  <a16:creationId xmlns:a16="http://schemas.microsoft.com/office/drawing/2014/main" id="{5C6B1BD7-4AF3-C37D-7D6C-9ED83BA1D990}"/>
                </a:ext>
              </a:extLst>
            </p:cNvPr>
            <p:cNvSpPr txBox="1"/>
            <p:nvPr/>
          </p:nvSpPr>
          <p:spPr>
            <a:xfrm>
              <a:off x="11043038" y="-3202629"/>
              <a:ext cx="2507937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ultiVI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文本框 191">
              <a:extLst>
                <a:ext uri="{FF2B5EF4-FFF2-40B4-BE49-F238E27FC236}">
                  <a16:creationId xmlns:a16="http://schemas.microsoft.com/office/drawing/2014/main" id="{A6B60930-5497-A361-4B12-275656AF261B}"/>
                </a:ext>
              </a:extLst>
            </p:cNvPr>
            <p:cNvSpPr txBox="1"/>
            <p:nvPr/>
          </p:nvSpPr>
          <p:spPr>
            <a:xfrm rot="16200000">
              <a:off x="-1346200" y="-1536404"/>
              <a:ext cx="333245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ed RNA profil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文本框 192">
              <a:extLst>
                <a:ext uri="{FF2B5EF4-FFF2-40B4-BE49-F238E27FC236}">
                  <a16:creationId xmlns:a16="http://schemas.microsoft.com/office/drawing/2014/main" id="{93E2F150-D6E8-52EE-C8D8-D0C17754FC33}"/>
                </a:ext>
              </a:extLst>
            </p:cNvPr>
            <p:cNvSpPr txBox="1"/>
            <p:nvPr/>
          </p:nvSpPr>
          <p:spPr>
            <a:xfrm rot="16200000">
              <a:off x="-1346200" y="2079385"/>
              <a:ext cx="333245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ed ATAC profil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43090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43</Words>
  <Application>Microsoft Office PowerPoint</Application>
  <PresentationFormat>自定义</PresentationFormat>
  <Paragraphs>1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1</cp:revision>
  <dcterms:created xsi:type="dcterms:W3CDTF">2024-12-11T03:02:09Z</dcterms:created>
  <dcterms:modified xsi:type="dcterms:W3CDTF">2024-12-11T03:03:18Z</dcterms:modified>
</cp:coreProperties>
</file>